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91" d="100"/>
          <a:sy n="91" d="100"/>
        </p:scale>
        <p:origin x="37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4346212-860F-43B6-B5DB-5CA81AC49CA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34F8D295-33A6-440D-A93B-53449C0BC08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752E11E-0CB0-43B7-813F-36F83F57ED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39AED7-E560-4AB4-A598-564FF595E0C5}" type="datetimeFigureOut">
              <a:rPr lang="zh-CN" altLang="en-US" smtClean="0"/>
              <a:t>2021/8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C70D506-AC3B-4942-9859-533C0A8B86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2F437BB-5A37-4AE5-994F-DF9603A6A4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702A70-8065-4067-8D65-3BCF4BF541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966708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2441789-735F-443D-BACC-81F4D68992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EEB4866-E0CB-468A-88DF-D67562D4729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CD5DF7B-2FBA-4705-887C-7E2782FBEA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39AED7-E560-4AB4-A598-564FF595E0C5}" type="datetimeFigureOut">
              <a:rPr lang="zh-CN" altLang="en-US" smtClean="0"/>
              <a:t>2021/8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D8C537E-B0C4-4BBF-AD05-16102D3223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18ACEDF-E99B-44F2-9912-3600E7FC7C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702A70-8065-4067-8D65-3BCF4BF541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72745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CFEB1FC-638E-4560-90A6-34BBFBFB6AF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F4FF270-3636-4F17-84BC-5970A5FD657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33FEE5B-8A20-4F5C-A019-BA3C502B7A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39AED7-E560-4AB4-A598-564FF595E0C5}" type="datetimeFigureOut">
              <a:rPr lang="zh-CN" altLang="en-US" smtClean="0"/>
              <a:t>2021/8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FF2132E-D8C0-4A42-9DE0-86FB2EE1B8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9CFE0E5-DFA9-4B96-86F9-8FFF837897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702A70-8065-4067-8D65-3BCF4BF541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35153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9CCAFE2-BF43-42D3-B63F-E9B17475EA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0896A45-1D24-4094-A55A-4BBAD2C7053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8F32926-CBD9-432D-B7D4-0A4A832B94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39AED7-E560-4AB4-A598-564FF595E0C5}" type="datetimeFigureOut">
              <a:rPr lang="zh-CN" altLang="en-US" smtClean="0"/>
              <a:t>2021/8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098F352-D9F8-4CAA-9184-810EE34D24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362C201-5735-45A2-A1FF-F2E21F9B6D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702A70-8065-4067-8D65-3BCF4BF541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22371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03694D8-5CF3-4E20-9637-D243739F3D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E39B709-3DA7-4844-9DBD-3243780060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5FB2E2F-5CCC-4027-AD7C-7368352CD4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39AED7-E560-4AB4-A598-564FF595E0C5}" type="datetimeFigureOut">
              <a:rPr lang="zh-CN" altLang="en-US" smtClean="0"/>
              <a:t>2021/8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05DD95C-AAB6-434C-AA8D-C97ACB517F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C197627-2363-4779-A183-62C756424F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702A70-8065-4067-8D65-3BCF4BF541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54933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45BC266-8D4E-4310-A486-D4ADA810AA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47DB6B6-563E-48E7-A413-494B3E2CFF6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5C18067-C26D-4D78-8687-406C0A49E65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C8ABA81-0414-4DA5-BF21-C299A1C4D9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39AED7-E560-4AB4-A598-564FF595E0C5}" type="datetimeFigureOut">
              <a:rPr lang="zh-CN" altLang="en-US" smtClean="0"/>
              <a:t>2021/8/1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CD2BCF5-6838-4DCF-A96F-6DC3E2561D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09272BD-8DAF-44B0-B8CD-1C208A03FD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702A70-8065-4067-8D65-3BCF4BF541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8986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41DFD9C-6C1F-4810-9AA0-B1E9135846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A2CD62C-C526-4348-896A-D35531A1B9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16B530B-C4E4-4B29-A902-25E09FFE03C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B1D893C9-409F-4C90-B717-C9E7E082F97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382E2575-4EEE-4B59-B016-E1551254181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F9C3CB31-B02E-4C77-BD34-257822DA11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39AED7-E560-4AB4-A598-564FF595E0C5}" type="datetimeFigureOut">
              <a:rPr lang="zh-CN" altLang="en-US" smtClean="0"/>
              <a:t>2021/8/10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C408181E-4A74-4185-AC89-BE3AE77015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1BFB87D6-9EA5-482C-B7BE-CC2427978F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702A70-8065-4067-8D65-3BCF4BF541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49963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0B781CB-2FAC-47EC-8EBA-C6AD313437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C247599E-8F22-4F9E-AD78-C9DEC24E70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39AED7-E560-4AB4-A598-564FF595E0C5}" type="datetimeFigureOut">
              <a:rPr lang="zh-CN" altLang="en-US" smtClean="0"/>
              <a:t>2021/8/10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3CB39AE9-717E-434E-A43F-4203F73BAE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ED2C7741-F14C-49AD-9A82-ACEF061C26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702A70-8065-4067-8D65-3BCF4BF541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75255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6246FD1-BD8F-4C07-BE07-3D45B79B92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39AED7-E560-4AB4-A598-564FF595E0C5}" type="datetimeFigureOut">
              <a:rPr lang="zh-CN" altLang="en-US" smtClean="0"/>
              <a:t>2021/8/10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47EAE213-48B0-4570-B120-FBBE692051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E2C04F0C-5823-4AE2-B121-C7BC59267F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702A70-8065-4067-8D65-3BCF4BF541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978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8B8B841-A9EA-4F36-ABD3-878CAADBB9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8FB991E-4077-4F46-96A6-9A34C95B84C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753589F-D5CD-4C21-82BE-C1AC9E8A01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654BA7D-141E-497F-97B5-1C311BD73E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39AED7-E560-4AB4-A598-564FF595E0C5}" type="datetimeFigureOut">
              <a:rPr lang="zh-CN" altLang="en-US" smtClean="0"/>
              <a:t>2021/8/1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D96A43A-2D8D-4F5F-829C-B4F7A913ED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97ECC9F-BE23-4ADD-8F05-ECF2E3885C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702A70-8065-4067-8D65-3BCF4BF541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402720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2D9EF8E-BBFE-4615-90B8-09FA0501C2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79017D8F-F0FB-415C-90CF-D3112B85E20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F477BEC-8643-44D4-A059-39A322B9F67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0DDBA02-E0D9-41C0-A71D-78CF30A1FF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39AED7-E560-4AB4-A598-564FF595E0C5}" type="datetimeFigureOut">
              <a:rPr lang="zh-CN" altLang="en-US" smtClean="0"/>
              <a:t>2021/8/1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87082DE-6D7C-4E5C-B4D7-638254B32B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9BC42AD-BB3D-4393-BFCD-8F1695AC53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702A70-8065-4067-8D65-3BCF4BF541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519971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225358DF-D79F-4520-8A4E-00A606C560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90A5992-8FEF-4F6A-991F-EC309D17FB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1E141F5-51B2-4002-927C-B1C8CBB9AFF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39AED7-E560-4AB4-A598-564FF595E0C5}" type="datetimeFigureOut">
              <a:rPr lang="zh-CN" altLang="en-US" smtClean="0"/>
              <a:t>2021/8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37AF2BE-B859-4D60-B7E2-FDFC55C08E8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77EB7C1-2AA6-4BE4-91DA-C168863A88E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702A70-8065-4067-8D65-3BCF4BF541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10628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E438003F-38B0-429C-9C1B-8D291D16116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770" y="1"/>
            <a:ext cx="3837614" cy="2852256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5B0B04E4-DD33-463A-8A7D-236548F332C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43492" y="0"/>
            <a:ext cx="3932689" cy="2852256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0ADF5B4C-5741-4BE0-9F2B-C2712C457F5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81106" y="1"/>
            <a:ext cx="3613907" cy="2852255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516DE2CC-3162-4FED-A601-91656BEF149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770" y="2852256"/>
            <a:ext cx="3837614" cy="2852255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2E7CDAC1-9A66-42BF-9931-F53904C4D752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43492" y="2852255"/>
            <a:ext cx="3613907" cy="2852255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77A24886-B710-4A0D-9C31-9631A82B2897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05605" y="2852255"/>
            <a:ext cx="3358394" cy="2852257"/>
          </a:xfrm>
          <a:prstGeom prst="rect">
            <a:avLst/>
          </a:prstGeom>
        </p:spPr>
      </p:pic>
      <p:sp>
        <p:nvSpPr>
          <p:cNvPr id="18" name="文本框 17">
            <a:extLst>
              <a:ext uri="{FF2B5EF4-FFF2-40B4-BE49-F238E27FC236}">
                <a16:creationId xmlns:a16="http://schemas.microsoft.com/office/drawing/2014/main" id="{63BD3AD7-8588-497B-AE99-575E059E022B}"/>
              </a:ext>
            </a:extLst>
          </p:cNvPr>
          <p:cNvSpPr txBox="1"/>
          <p:nvPr/>
        </p:nvSpPr>
        <p:spPr>
          <a:xfrm>
            <a:off x="184558" y="5934669"/>
            <a:ext cx="1156841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S1: Volcano plot of differentially expressed miRNAs in T0 vs.T1, T0 vs. T2, T0 vs T3, T1 vs.T2 and T2 vs T3. The red and green dots represent up-regulated and down-regulated differentially </a:t>
            </a:r>
            <a:r>
              <a:rPr lang="en-US" altLang="zh-CN"/>
              <a:t>expressed miRNAs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9972947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CCE8C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6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巧欣</dc:creator>
  <cp:lastModifiedBy>王 巧欣</cp:lastModifiedBy>
  <cp:revision>2</cp:revision>
  <dcterms:created xsi:type="dcterms:W3CDTF">2021-08-03T08:13:55Z</dcterms:created>
  <dcterms:modified xsi:type="dcterms:W3CDTF">2021-08-10T03:02:46Z</dcterms:modified>
</cp:coreProperties>
</file>